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7099300" cy="102346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7" d="100"/>
          <a:sy n="47" d="100"/>
        </p:scale>
        <p:origin x="-1056" y="-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5BD0D0-56C1-44BB-B636-9B21D9907328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6D17A7-8DED-410B-8054-FCADDC52C28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7EEA4A-0C8F-40DA-BC83-65540A60BCF4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74DD2B-4D66-49E1-B053-223D2C79193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3D745F-B644-42FF-8381-09CAE379A7A5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7B4322-0A1F-48B3-A922-1367668793F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C35871-AB2A-42D9-869B-0FE5032C5649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D3A17C-5D13-48EF-81F3-8B4F2F484D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517DFC-6240-4361-B796-E5FADBA3DA22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C3726-85A3-4B32-944C-427855DF0D7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961DBB-CBDB-480B-95C4-20AF18A824FD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872047-F6DC-4FB2-A746-92056002B8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E86181-E890-42DA-BB7E-C6FEA56E4E54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5618F3-65A9-4B18-935D-13213D78A7B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B1B1A7-7CAD-4B97-8145-005F171174D7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6FF1CF-9CCB-4CC6-AC47-6E4D4C88FD7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1AF709-6C5F-4847-B422-6B7D1DAD4F9D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72D814-5627-41F3-A61A-9F243F22946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376F3B-0393-4B4D-99D2-6E22DE5C69E9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721757-E7F5-45E7-945A-7BB2ABFBE9B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44F58E-6C05-4042-87E2-4B92E2CE2DBF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45C6D3-3C73-4476-BF92-FF9A38CF52C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4F50AD8-D9F2-4CA8-9D63-49B5771933EE}" type="datetimeFigureOut">
              <a:rPr lang="ja-JP" altLang="en-US"/>
              <a:pPr>
                <a:defRPr/>
              </a:pPr>
              <a:t>2015/5/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408A6D7F-F240-4E48-B080-CAFFE518B95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package" Target="../embeddings/Microsoft_Excel_Worksheet1.xlsx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1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5888" y="581085"/>
            <a:ext cx="6467475" cy="6399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00" name="正方形/長方形 5"/>
          <p:cNvSpPr>
            <a:spLocks noChangeArrowheads="1"/>
          </p:cNvSpPr>
          <p:nvPr/>
        </p:nvSpPr>
        <p:spPr bwMode="auto">
          <a:xfrm>
            <a:off x="0" y="312797"/>
            <a:ext cx="6270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>
                <a:latin typeface="Calibri" pitchFamily="34" charset="0"/>
              </a:rPr>
              <a:t>a) Gain</a:t>
            </a:r>
            <a:endParaRPr lang="ja-JP" altLang="en-US" sz="1200"/>
          </a:p>
        </p:txBody>
      </p:sp>
      <p:sp>
        <p:nvSpPr>
          <p:cNvPr id="4101" name="正方形/長方形 6"/>
          <p:cNvSpPr>
            <a:spLocks noChangeArrowheads="1"/>
          </p:cNvSpPr>
          <p:nvPr/>
        </p:nvSpPr>
        <p:spPr bwMode="auto">
          <a:xfrm>
            <a:off x="44450" y="2033647"/>
            <a:ext cx="6143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>
                <a:latin typeface="Calibri" pitchFamily="34" charset="0"/>
              </a:rPr>
              <a:t>b) Loss</a:t>
            </a:r>
            <a:endParaRPr lang="ja-JP" altLang="en-US" sz="1200"/>
          </a:p>
        </p:txBody>
      </p:sp>
      <p:sp>
        <p:nvSpPr>
          <p:cNvPr id="4102" name="正方形/長方形 7"/>
          <p:cNvSpPr>
            <a:spLocks noChangeArrowheads="1"/>
          </p:cNvSpPr>
          <p:nvPr/>
        </p:nvSpPr>
        <p:spPr bwMode="auto">
          <a:xfrm>
            <a:off x="44450" y="4408547"/>
            <a:ext cx="1951038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>
                <a:latin typeface="Calibri" pitchFamily="34" charset="0"/>
              </a:rPr>
              <a:t>c) Copy number neutral LOH</a:t>
            </a:r>
            <a:endParaRPr lang="ja-JP" altLang="en-US" sz="1200"/>
          </a:p>
        </p:txBody>
      </p:sp>
      <p:graphicFrame>
        <p:nvGraphicFramePr>
          <p:cNvPr id="4103" name="Object 7"/>
          <p:cNvGraphicFramePr>
            <a:graphicFrameLocks noChangeAspect="1"/>
          </p:cNvGraphicFramePr>
          <p:nvPr/>
        </p:nvGraphicFramePr>
        <p:xfrm>
          <a:off x="188913" y="7278747"/>
          <a:ext cx="5903912" cy="140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4" name="ワークシート" r:id="rId5" imgW="8991645" imgH="2133540" progId="Excel.Sheet.12">
                  <p:embed/>
                </p:oleObj>
              </mc:Choice>
              <mc:Fallback>
                <p:oleObj name="ワークシート" r:id="rId5" imgW="8991645" imgH="2133540" progId="Excel.Sheet.12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8913" y="7278747"/>
                        <a:ext cx="5903912" cy="14001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04" name="正方形/長方形 8"/>
          <p:cNvSpPr>
            <a:spLocks noChangeArrowheads="1"/>
          </p:cNvSpPr>
          <p:nvPr/>
        </p:nvSpPr>
        <p:spPr bwMode="auto">
          <a:xfrm>
            <a:off x="115888" y="6989822"/>
            <a:ext cx="2081212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>
                <a:solidFill>
                  <a:srgbClr val="000000"/>
                </a:solidFill>
                <a:latin typeface="Calibri" pitchFamily="34" charset="0"/>
              </a:rPr>
              <a:t>d) Homozygous deletions (HD)</a:t>
            </a:r>
            <a:endParaRPr lang="ja-JP" altLang="en-US" sz="1200">
              <a:solidFill>
                <a:srgbClr val="000000"/>
              </a:solidFill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188640" y="8676456"/>
            <a:ext cx="46335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Calibri" pitchFamily="34" charset="0"/>
              </a:rPr>
              <a:t>S: Serous carcinoma, E: </a:t>
            </a:r>
            <a:r>
              <a:rPr lang="en-US" altLang="ja-JP" sz="1200" dirty="0" err="1" smtClean="0">
                <a:solidFill>
                  <a:prstClr val="black"/>
                </a:solidFill>
                <a:latin typeface="Calibri" pitchFamily="34" charset="0"/>
              </a:rPr>
              <a:t>Endometioid</a:t>
            </a:r>
            <a:r>
              <a:rPr lang="en-US" altLang="ja-JP" sz="1200" dirty="0" smtClean="0">
                <a:solidFill>
                  <a:prstClr val="black"/>
                </a:solidFill>
                <a:latin typeface="Calibri" pitchFamily="34" charset="0"/>
              </a:rPr>
              <a:t> carcinoma, C: Clear cell carcinoma</a:t>
            </a:r>
            <a:endParaRPr lang="ja-JP" altLang="en-US" dirty="0"/>
          </a:p>
        </p:txBody>
      </p:sp>
      <p:sp>
        <p:nvSpPr>
          <p:cNvPr id="2" name="正方形/長方形 1"/>
          <p:cNvSpPr/>
          <p:nvPr/>
        </p:nvSpPr>
        <p:spPr>
          <a:xfrm>
            <a:off x="116632" y="103148"/>
            <a:ext cx="6506369" cy="2923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300" b="1" dirty="0"/>
              <a:t>S3 Table. The regions of copy number alterations and cancer-related genes.</a:t>
            </a:r>
            <a:endParaRPr lang="ja-JP" altLang="ja-JP" sz="13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</TotalTime>
  <Words>47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Office テーマ</vt:lpstr>
      <vt:lpstr>ワークシート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DA Family</dc:creator>
  <cp:lastModifiedBy>Katsutoshi</cp:lastModifiedBy>
  <cp:revision>18</cp:revision>
  <dcterms:created xsi:type="dcterms:W3CDTF">2011-05-05T11:01:26Z</dcterms:created>
  <dcterms:modified xsi:type="dcterms:W3CDTF">2015-05-01T14:47:03Z</dcterms:modified>
</cp:coreProperties>
</file>